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757"/>
    <p:restoredTop sz="94723"/>
  </p:normalViewPr>
  <p:slideViewPr>
    <p:cSldViewPr>
      <p:cViewPr>
        <p:scale>
          <a:sx n="55" d="100"/>
          <a:sy n="55" d="100"/>
        </p:scale>
        <p:origin x="-2544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971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4498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0219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5091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058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6602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596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3167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5693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923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699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5CD75-2B7A-47D7-A7B8-5EA302627BB6}" type="datetimeFigureOut">
              <a:rPr lang="es-ES" smtClean="0"/>
              <a:t>17/07/202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1BF97-B726-40B1-8AB1-B37BC2DA332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5823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3 Imagen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04" t="15942" r="40691" b="13664"/>
          <a:stretch/>
        </p:blipFill>
        <p:spPr>
          <a:xfrm>
            <a:off x="1556792" y="1502584"/>
            <a:ext cx="3096344" cy="4359654"/>
          </a:xfrm>
          <a:prstGeom prst="rect">
            <a:avLst/>
          </a:prstGeom>
        </p:spPr>
      </p:pic>
      <p:sp>
        <p:nvSpPr>
          <p:cNvPr id="5" name="4 CuadroTexto"/>
          <p:cNvSpPr txBox="1"/>
          <p:nvPr/>
        </p:nvSpPr>
        <p:spPr>
          <a:xfrm>
            <a:off x="161137" y="377004"/>
            <a:ext cx="6699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Gel 1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corresponds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 smtClean="0">
                <a:latin typeface="Times New Roman" pitchFamily="18" charset="0"/>
                <a:cs typeface="Times New Roman" pitchFamily="18" charset="0"/>
              </a:rPr>
              <a:t>Coomasie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 smtClean="0">
                <a:latin typeface="Times New Roman" pitchFamily="18" charset="0"/>
                <a:cs typeface="Times New Roman" pitchFamily="18" charset="0"/>
              </a:rPr>
              <a:t>stained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 gel Figure 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3 of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manuscript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404664" y="6084168"/>
            <a:ext cx="6048672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ing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ord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6.</a:t>
            </a:r>
          </a:p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molecular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igh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mark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2 and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urifi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otei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TIH4 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porcine plasm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res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(3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6).</a:t>
            </a:r>
          </a:p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urifi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otei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ou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io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, pre-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/10 and 1/100,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, 3, and 4,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respectively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; and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rea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DDT,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heated 5 and 20 minutes in lanes 5 and 6, respectively.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 algn="just"/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Method used to capture the image was a camera imaging system for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chemiluminescenc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western blotting and colorimetric image capture (Automatic molecular imaging system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ImageQuan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™ 500).</a:t>
            </a:r>
          </a:p>
          <a:p>
            <a:pPr algn="just"/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The edges were cropped from the original image to generate the figure panel  of the manuscript.</a:t>
            </a:r>
            <a:endParaRPr lang="es-E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7 Cuadro de texto"/>
          <p:cNvSpPr txBox="1"/>
          <p:nvPr/>
        </p:nvSpPr>
        <p:spPr>
          <a:xfrm>
            <a:off x="1860636" y="1117601"/>
            <a:ext cx="2488653" cy="238125"/>
          </a:xfrm>
          <a:prstGeom prst="rect">
            <a:avLst/>
          </a:prstGeom>
          <a:solidFill>
            <a:schemeClr val="lt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1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1          2          3        4        5        6</a:t>
            </a:r>
            <a:endParaRPr lang="es-ES" sz="1100" dirty="0">
              <a:effectLst/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4812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404664" y="395536"/>
            <a:ext cx="5926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Gel 2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corresponds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Western </a:t>
            </a:r>
            <a:r>
              <a:rPr lang="es-ES" dirty="0" err="1" smtClean="0">
                <a:latin typeface="Times New Roman" pitchFamily="18" charset="0"/>
                <a:cs typeface="Times New Roman" pitchFamily="18" charset="0"/>
              </a:rPr>
              <a:t>Blot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4 of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manuscript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373293" y="5760689"/>
            <a:ext cx="6264696" cy="3293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ing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ord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2.</a:t>
            </a:r>
          </a:p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molecular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igh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mark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, porcine saliv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3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7 , and pre-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/10 porcine plasm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8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2.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Eac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fferen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ig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urifi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TIH4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ou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io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o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reatmen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2.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membr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eviously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incuba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commercial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TIH4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ntibody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gains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smtClean="0">
                <a:latin typeface="Times New Roman" pitchFamily="18" charset="0"/>
                <a:cs typeface="Times New Roman" pitchFamily="18" charset="0"/>
              </a:rPr>
              <a:t>ITIH4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bel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HRP. </a:t>
            </a:r>
          </a:p>
          <a:p>
            <a:pPr algn="just"/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Method used to capture the image was a camera imaging system for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chemiluminescenc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western blotting and colorimetric image capture (Automatic molecular imaging system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ImageQuan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™ 500). The edges were cropped from the original image to generate the figure panel of the manuscript.</a:t>
            </a:r>
            <a:endParaRPr lang="es-ES" sz="16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s-E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1 Imagen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26" b="15139"/>
          <a:stretch/>
        </p:blipFill>
        <p:spPr>
          <a:xfrm>
            <a:off x="779098" y="1318582"/>
            <a:ext cx="5688632" cy="4313968"/>
          </a:xfrm>
          <a:prstGeom prst="rect">
            <a:avLst/>
          </a:prstGeom>
        </p:spPr>
      </p:pic>
      <p:sp>
        <p:nvSpPr>
          <p:cNvPr id="3" name="2 Rectángulo"/>
          <p:cNvSpPr/>
          <p:nvPr/>
        </p:nvSpPr>
        <p:spPr>
          <a:xfrm>
            <a:off x="1556792" y="1056972"/>
            <a:ext cx="468052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dirty="0"/>
              <a:t> </a:t>
            </a:r>
            <a:r>
              <a:rPr lang="en-GB" sz="1100" dirty="0">
                <a:latin typeface="Times New Roman" pitchFamily="18" charset="0"/>
                <a:cs typeface="Times New Roman" pitchFamily="18" charset="0"/>
              </a:rPr>
              <a:t>1         2         3       4        5         6        7       8         9      10     11     12</a:t>
            </a:r>
            <a:endParaRPr lang="es-E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0493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404664" y="395536"/>
            <a:ext cx="5926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Gel 3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corresponds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Western </a:t>
            </a:r>
            <a:r>
              <a:rPr lang="es-ES" dirty="0" err="1" smtClean="0">
                <a:latin typeface="Times New Roman" pitchFamily="18" charset="0"/>
                <a:cs typeface="Times New Roman" pitchFamily="18" charset="0"/>
              </a:rPr>
              <a:t>Blot</a:t>
            </a:r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5 of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dirty="0" err="1">
                <a:latin typeface="Times New Roman" pitchFamily="18" charset="0"/>
                <a:cs typeface="Times New Roman" pitchFamily="18" charset="0"/>
              </a:rPr>
              <a:t>manuscript</a:t>
            </a:r>
            <a:r>
              <a:rPr lang="es-ES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239220" y="5436096"/>
            <a:ext cx="6408712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ing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ord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2.</a:t>
            </a:r>
          </a:p>
          <a:p>
            <a:pPr algn="just"/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molecular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igh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marke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, porcine saliv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3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7 and pre-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/10 porcine plasm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8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o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12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Each sample was from a different pig.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urifi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otei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oad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ou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dilution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or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reatmen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2.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membran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eviously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incubat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a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olyclonal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TIH4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ntibody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agains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porcine ITIH4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that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produc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house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labeled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600" dirty="0" err="1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es-ES" sz="1600" dirty="0">
                <a:latin typeface="Times New Roman" pitchFamily="18" charset="0"/>
                <a:cs typeface="Times New Roman" pitchFamily="18" charset="0"/>
              </a:rPr>
              <a:t> HRP. </a:t>
            </a:r>
          </a:p>
          <a:p>
            <a:pPr algn="just"/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Method used to capture the image was a camera imaging system for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chemiluminescenc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western blotting and colorimetric image capture (Automatic molecular imaging system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ImageQuan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™ 500). The edges were cropped from the original image to generate the figure panel of the manuscript.</a:t>
            </a:r>
            <a:endParaRPr lang="es-ES" sz="16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s-E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2 Rectángulo"/>
          <p:cNvSpPr/>
          <p:nvPr/>
        </p:nvSpPr>
        <p:spPr>
          <a:xfrm>
            <a:off x="1124744" y="1187777"/>
            <a:ext cx="41044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dirty="0"/>
              <a:t> </a:t>
            </a:r>
            <a:r>
              <a:rPr lang="en-GB" sz="1100" dirty="0">
                <a:latin typeface="Times New Roman" pitchFamily="18" charset="0"/>
                <a:cs typeface="Times New Roman" pitchFamily="18" charset="0"/>
              </a:rPr>
              <a:t>1        2       3       4       5       6      7       8      9      10     11     12</a:t>
            </a:r>
            <a:endParaRPr lang="es-ES" sz="11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3 Imagen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05" b="9447"/>
          <a:stretch/>
        </p:blipFill>
        <p:spPr>
          <a:xfrm>
            <a:off x="620688" y="1449387"/>
            <a:ext cx="5112568" cy="3836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6118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463</Words>
  <Application>Microsoft Office PowerPoint</Application>
  <PresentationFormat>Presentación en pantalla (4:3)</PresentationFormat>
  <Paragraphs>18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a ortin bustillo</dc:creator>
  <cp:lastModifiedBy>alba ortin bustillo</cp:lastModifiedBy>
  <cp:revision>19</cp:revision>
  <dcterms:created xsi:type="dcterms:W3CDTF">2025-07-16T21:25:33Z</dcterms:created>
  <dcterms:modified xsi:type="dcterms:W3CDTF">2025-07-17T09:37:02Z</dcterms:modified>
</cp:coreProperties>
</file>